
<file path=[Content_Types].xml><?xml version="1.0" encoding="utf-8"?>
<Types xmlns="http://schemas.openxmlformats.org/package/2006/content-types">
  <Default Extension="png" ContentType="image/png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Default Extension="wdp" ContentType="image/vnd.ms-photo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3282" y="-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0B2DB-12FA-4022-AB38-98619C22A963}" type="datetimeFigureOut">
              <a:rPr lang="fr-FR" smtClean="0"/>
              <a:t>29/06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A9DBB-C6CA-4F9F-8099-A9AB8B42BA6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234217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0B2DB-12FA-4022-AB38-98619C22A963}" type="datetimeFigureOut">
              <a:rPr lang="fr-FR" smtClean="0"/>
              <a:t>29/06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A9DBB-C6CA-4F9F-8099-A9AB8B42BA6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715276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0B2DB-12FA-4022-AB38-98619C22A963}" type="datetimeFigureOut">
              <a:rPr lang="fr-FR" smtClean="0"/>
              <a:t>29/06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A9DBB-C6CA-4F9F-8099-A9AB8B42BA6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755997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0B2DB-12FA-4022-AB38-98619C22A963}" type="datetimeFigureOut">
              <a:rPr lang="fr-FR" smtClean="0"/>
              <a:t>29/06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A9DBB-C6CA-4F9F-8099-A9AB8B42BA6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801918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0B2DB-12FA-4022-AB38-98619C22A963}" type="datetimeFigureOut">
              <a:rPr lang="fr-FR" smtClean="0"/>
              <a:t>29/06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A9DBB-C6CA-4F9F-8099-A9AB8B42BA6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109557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0B2DB-12FA-4022-AB38-98619C22A963}" type="datetimeFigureOut">
              <a:rPr lang="fr-FR" smtClean="0"/>
              <a:t>29/06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A9DBB-C6CA-4F9F-8099-A9AB8B42BA6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116429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0B2DB-12FA-4022-AB38-98619C22A963}" type="datetimeFigureOut">
              <a:rPr lang="fr-FR" smtClean="0"/>
              <a:t>29/06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A9DBB-C6CA-4F9F-8099-A9AB8B42BA6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261980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0B2DB-12FA-4022-AB38-98619C22A963}" type="datetimeFigureOut">
              <a:rPr lang="fr-FR" smtClean="0"/>
              <a:t>29/06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A9DBB-C6CA-4F9F-8099-A9AB8B42BA6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381156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0B2DB-12FA-4022-AB38-98619C22A963}" type="datetimeFigureOut">
              <a:rPr lang="fr-FR" smtClean="0"/>
              <a:t>29/06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A9DBB-C6CA-4F9F-8099-A9AB8B42BA6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536696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0B2DB-12FA-4022-AB38-98619C22A963}" type="datetimeFigureOut">
              <a:rPr lang="fr-FR" smtClean="0"/>
              <a:t>29/06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A9DBB-C6CA-4F9F-8099-A9AB8B42BA6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83340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0B2DB-12FA-4022-AB38-98619C22A963}" type="datetimeFigureOut">
              <a:rPr lang="fr-FR" smtClean="0"/>
              <a:t>29/06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A9DBB-C6CA-4F9F-8099-A9AB8B42BA6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007108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40B2DB-12FA-4022-AB38-98619C22A963}" type="datetimeFigureOut">
              <a:rPr lang="fr-FR" smtClean="0"/>
              <a:t>29/06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6A9DBB-C6CA-4F9F-8099-A9AB8B42BA6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341606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/>
          <p:cNvSpPr txBox="1"/>
          <p:nvPr/>
        </p:nvSpPr>
        <p:spPr>
          <a:xfrm>
            <a:off x="516704" y="4138986"/>
            <a:ext cx="25188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GUX</a:t>
            </a:r>
            <a:r>
              <a:rPr lang="fr-F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tholog</a:t>
            </a:r>
            <a:r>
              <a:rPr lang="fr-F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MZM2G096946 </a:t>
            </a:r>
            <a:endParaRPr lang="fr-FR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ZoneTexte 4"/>
          <p:cNvSpPr txBox="1"/>
          <p:nvPr/>
        </p:nvSpPr>
        <p:spPr>
          <a:xfrm>
            <a:off x="4190998" y="4152262"/>
            <a:ext cx="24957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XAT</a:t>
            </a:r>
            <a:r>
              <a:rPr lang="fr-F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tholog</a:t>
            </a:r>
            <a:r>
              <a:rPr lang="fr-F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RMZM2G096946</a:t>
            </a:r>
            <a:endParaRPr lang="fr-FR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Picture 2" descr="http://bar.utoronto.ca/efp_maize/cgi-bin/output/efp-r9jIJD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6146" y="1259632"/>
            <a:ext cx="3240000" cy="259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ZoneTexte 6"/>
          <p:cNvSpPr txBox="1"/>
          <p:nvPr/>
        </p:nvSpPr>
        <p:spPr>
          <a:xfrm>
            <a:off x="805227" y="1015105"/>
            <a:ext cx="23762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AHD-FT</a:t>
            </a:r>
            <a:r>
              <a:rPr lang="fr-F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? GRMZM2G314898</a:t>
            </a:r>
            <a:endParaRPr lang="fr-FR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" name="Picture 2" descr="http://bar.utoronto.ca/efp_maize/cgi-bin/output/efp-SI5JIB.pn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18730" y="1259632"/>
            <a:ext cx="3240000" cy="259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" name="ZoneTexte 12"/>
          <p:cNvSpPr txBox="1"/>
          <p:nvPr/>
        </p:nvSpPr>
        <p:spPr>
          <a:xfrm>
            <a:off x="3842586" y="1010556"/>
            <a:ext cx="25922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IRX14 </a:t>
            </a:r>
            <a:r>
              <a:rPr lang="fr-FR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tholog</a:t>
            </a:r>
            <a:r>
              <a:rPr lang="fr-F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MZM2G113655 </a:t>
            </a:r>
            <a:endParaRPr lang="fr-FR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6" name="Picture 2" descr="http://bar.utoronto.ca/efp_maize/cgi-bin/output/efp-gPysOk.pn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4036" y="4499027"/>
            <a:ext cx="3240000" cy="259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http://bar.utoronto.ca/efp_maize/cgi-bin/output/efp-LSrjsk.pn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18730" y="4499027"/>
            <a:ext cx="3240000" cy="259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ZoneTexte 14"/>
          <p:cNvSpPr txBox="1"/>
          <p:nvPr/>
        </p:nvSpPr>
        <p:spPr>
          <a:xfrm>
            <a:off x="463575" y="7596336"/>
            <a:ext cx="586514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ure 3 : Expression profiles of </a:t>
            </a:r>
            <a:r>
              <a:rPr lang="fr-FR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s</a:t>
            </a:r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tentially</a:t>
            </a:r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volved</a:t>
            </a:r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fr-FR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ucuronoarabinoxylan</a:t>
            </a:r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ynthesis</a:t>
            </a:r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fr-FR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eruloylation</a:t>
            </a:r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the </a:t>
            </a:r>
            <a:r>
              <a:rPr lang="fr-FR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imary</a:t>
            </a:r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oot</a:t>
            </a:r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fr-FR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ize</a:t>
            </a:r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edlings</a:t>
            </a:r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 algn="just"/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ize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FP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rowser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vailable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via the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izeGDB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bsite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0472345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F3304DEAE09B24DA68D64CBB702879E" ma:contentTypeVersion="7" ma:contentTypeDescription="Create a new document." ma:contentTypeScope="" ma:versionID="56f4917bd8fe5572caa8ce3e64525f08">
  <xsd:schema xmlns:xsd="http://www.w3.org/2001/XMLSchema" xmlns:p="http://schemas.microsoft.com/office/2006/metadata/properties" xmlns:ns2="28de4f29-e3d9-478e-b05a-16a8ff0eb393" targetNamespace="http://schemas.microsoft.com/office/2006/metadata/properties" ma:root="true" ma:fieldsID="90fc53ae50983f9ac236714ed868e368" ns2:_="">
    <xsd:import namespace="28de4f29-e3d9-478e-b05a-16a8ff0eb393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28de4f29-e3d9-478e-b05a-16a8ff0eb393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Id xmlns="28de4f29-e3d9-478e-b05a-16a8ff0eb393">Presentation 3.PPTX</DocumentId>
    <StageName xmlns="28de4f29-e3d9-478e-b05a-16a8ff0eb393" xsi:nil="true"/>
    <IsDeleted xmlns="28de4f29-e3d9-478e-b05a-16a8ff0eb393">false</IsDeleted>
    <FileFormat xmlns="28de4f29-e3d9-478e-b05a-16a8ff0eb393">PPTX</FileFormat>
    <TitleName xmlns="28de4f29-e3d9-478e-b05a-16a8ff0eb393">Presentation 3.PPTX</TitleName>
    <DocumentType xmlns="28de4f29-e3d9-478e-b05a-16a8ff0eb393">Presentation</DocumentType>
    <Checked_x0020_Out_x0020_To xmlns="28de4f29-e3d9-478e-b05a-16a8ff0eb393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1747436B-3074-424F-B564-7E8E6D781ED7}"/>
</file>

<file path=customXml/itemProps2.xml><?xml version="1.0" encoding="utf-8"?>
<ds:datastoreItem xmlns:ds="http://schemas.openxmlformats.org/officeDocument/2006/customXml" ds:itemID="{1457E8B2-0BD7-4641-A973-D8F07382FFE1}"/>
</file>

<file path=customXml/itemProps3.xml><?xml version="1.0" encoding="utf-8"?>
<ds:datastoreItem xmlns:ds="http://schemas.openxmlformats.org/officeDocument/2006/customXml" ds:itemID="{B2FF00DF-3533-44C8-8D5E-7EB15E759E0B}"/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44</Words>
  <Application>Microsoft Office PowerPoint</Application>
  <PresentationFormat>Affichage à l'écran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INR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lchateigner</dc:creator>
  <cp:lastModifiedBy>alchateigner</cp:lastModifiedBy>
  <cp:revision>3</cp:revision>
  <dcterms:created xsi:type="dcterms:W3CDTF">2016-06-29T06:50:55Z</dcterms:created>
  <dcterms:modified xsi:type="dcterms:W3CDTF">2016-06-29T11:10:3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F3304DEAE09B24DA68D64CBB702879E</vt:lpwstr>
  </property>
</Properties>
</file>